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fa-I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RT Pack 20 DVDs" initials="MP2D" lastIdx="1" clrIdx="0">
    <p:extLst>
      <p:ext uri="{19B8F6BF-5375-455C-9EA6-DF929625EA0E}">
        <p15:presenceInfo xmlns:p15="http://schemas.microsoft.com/office/powerpoint/2012/main" userId="MRT Pack 20 DVD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374" autoAdjust="0"/>
  </p:normalViewPr>
  <p:slideViewPr>
    <p:cSldViewPr snapToGrid="0">
      <p:cViewPr varScale="1">
        <p:scale>
          <a:sx n="82" d="100"/>
          <a:sy n="82" d="100"/>
        </p:scale>
        <p:origin x="69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3582F1FA-6D48-448C-970A-66BE609E95DD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3C074EB9-6B0F-4569-A951-7A63C87761FC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634750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499234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561788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754041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36716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104283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38717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189703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69286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540640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200221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a-I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2882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a-I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a-I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623DA-C239-499A-8DAB-661F72BF1177}" type="datetimeFigureOut">
              <a:rPr lang="fa-IR" smtClean="0"/>
              <a:t>25/01/1445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1747B-B27F-4390-B9BF-0B3193C65221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056540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a-I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65265" y="5380672"/>
            <a:ext cx="11022677" cy="110799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4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: molecular size marker, 1: genomic DNA extracted from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ohnell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sp. A01, 2:circular plasmid, 3: Digested recombinant plasmid, 4: PCR product of the desired gene, 5: enzymatic digestion of recombinant plasmid, 6: empty digested vector with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de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 enzyme, 7:PCR colony, 8: PCR plasmid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AFCD4F3-E212-6240-DA63-D33FB8C8BC6B}"/>
              </a:ext>
            </a:extLst>
          </p:cNvPr>
          <p:cNvPicPr>
            <a:picLocks noChangeAspect="1"/>
          </p:cNvPicPr>
          <p:nvPr/>
        </p:nvPicPr>
        <p:blipFill>
          <a:blip r:embed="rId2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0938" y="553998"/>
            <a:ext cx="3594699" cy="45965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DBF495C-61E2-FDA1-0D37-C8FC942EBF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0938" y="183858"/>
            <a:ext cx="4004773" cy="37707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1C06F6B-7567-7B6E-1657-C9A1EA42B0A1}"/>
              </a:ext>
            </a:extLst>
          </p:cNvPr>
          <p:cNvSpPr txBox="1"/>
          <p:nvPr/>
        </p:nvSpPr>
        <p:spPr>
          <a:xfrm>
            <a:off x="8998085" y="3900951"/>
            <a:ext cx="12864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525 bp</a:t>
            </a:r>
            <a:endParaRPr lang="en-US" dirty="0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A30977F-6E15-EA7B-8E9D-546FE191366B}"/>
              </a:ext>
            </a:extLst>
          </p:cNvPr>
          <p:cNvCxnSpPr>
            <a:cxnSpLocks/>
          </p:cNvCxnSpPr>
          <p:nvPr/>
        </p:nvCxnSpPr>
        <p:spPr>
          <a:xfrm>
            <a:off x="8202037" y="4095345"/>
            <a:ext cx="796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59DA8762-04CD-EABE-9D4E-6C14EC944ACA}"/>
              </a:ext>
            </a:extLst>
          </p:cNvPr>
          <p:cNvSpPr txBox="1"/>
          <p:nvPr/>
        </p:nvSpPr>
        <p:spPr>
          <a:xfrm>
            <a:off x="3236069" y="3949589"/>
            <a:ext cx="12864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500 bp</a:t>
            </a:r>
            <a:endParaRPr lang="en-US" dirty="0"/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F48E391-3F54-3BDC-6D93-D8F6E4CE6EC2}"/>
              </a:ext>
            </a:extLst>
          </p:cNvPr>
          <p:cNvCxnSpPr>
            <a:cxnSpLocks/>
          </p:cNvCxnSpPr>
          <p:nvPr/>
        </p:nvCxnSpPr>
        <p:spPr>
          <a:xfrm>
            <a:off x="4113177" y="4134255"/>
            <a:ext cx="796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0FF0A0C3-B42A-F8A1-481D-554B4EA01729}"/>
              </a:ext>
            </a:extLst>
          </p:cNvPr>
          <p:cNvSpPr txBox="1"/>
          <p:nvPr/>
        </p:nvSpPr>
        <p:spPr>
          <a:xfrm>
            <a:off x="3024381" y="1825717"/>
            <a:ext cx="12864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5000 bp</a:t>
            </a:r>
            <a:endParaRPr lang="en-US" dirty="0"/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0F37B50-0EB5-D428-CD08-D5D50BCC9718}"/>
              </a:ext>
            </a:extLst>
          </p:cNvPr>
          <p:cNvCxnSpPr>
            <a:cxnSpLocks/>
          </p:cNvCxnSpPr>
          <p:nvPr/>
        </p:nvCxnSpPr>
        <p:spPr>
          <a:xfrm>
            <a:off x="3955287" y="2010383"/>
            <a:ext cx="7960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5853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7</TotalTime>
  <Words>7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RT www.Win2Farsi.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T Pack 20 DVDs</dc:creator>
  <cp:lastModifiedBy>red pc</cp:lastModifiedBy>
  <cp:revision>89</cp:revision>
  <dcterms:created xsi:type="dcterms:W3CDTF">2019-03-24T09:48:42Z</dcterms:created>
  <dcterms:modified xsi:type="dcterms:W3CDTF">2023-08-11T10:58:46Z</dcterms:modified>
</cp:coreProperties>
</file>